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1FF7F8-E2D6-4E24-A5DF-8BCF1B967706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1C98F9-D4B7-4DE9-8684-F3D4263FB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688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8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19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23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864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01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43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00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05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8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014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336812" y="379741"/>
          <a:ext cx="9286139" cy="63436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6944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6094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64030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5242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190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430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4001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714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111442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52864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64490">
                <a:tc gridSpan="4">
                  <a:txBody>
                    <a:bodyPr/>
                    <a:lstStyle/>
                    <a:p>
                      <a:pPr algn="ctr"/>
                      <a:r>
                        <a:rPr lang="en-US" sz="1400" baseline="0" dirty="0"/>
                        <a:t>AMY</a:t>
                      </a:r>
                      <a:endParaRPr lang="en-US" sz="14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1400" b="1" baseline="0"/>
                    </a:p>
                  </a:txBody>
                  <a:tcPr marR="0" marT="0" marB="0"/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en-US" sz="1400" baseline="0" dirty="0"/>
                        <a:t>ACC</a:t>
                      </a:r>
                      <a:endParaRPr lang="en-US" sz="14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8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2 weeks</a:t>
                      </a:r>
                      <a:endParaRPr lang="en-US" sz="1200" b="1" baseline="0" dirty="0"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5 weeks</a:t>
                      </a:r>
                      <a:endParaRPr lang="en-US" sz="12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1200" b="1" baseline="0"/>
                    </a:p>
                  </a:txBody>
                  <a:tcPr marR="0" marT="0" marB="0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2 weeks</a:t>
                      </a:r>
                      <a:endParaRPr lang="en-US" sz="12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US" sz="6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US" sz="600" b="1" baseline="0" dirty="0"/>
                    </a:p>
                  </a:txBody>
                  <a:tcPr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none" baseline="0" dirty="0"/>
                        <a:t>5 weeks</a:t>
                      </a:r>
                      <a:endParaRPr lang="en-US" sz="1200" b="1" u="none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 value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 valu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 valu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 value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ap1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4.8E-04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Morphine addiction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7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Axon guidance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6E-10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Osteoclast differentiation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6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FoxO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4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athways in cancer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3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Oxytocin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3E-07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Focal adhes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4E-09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regulating pluripotency of stem cells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9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MAPK signaling 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Lysine degrada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8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Retrograde endocannabinoid signaling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8.0E-07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drenergic signaling in cardiomyocyte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3E-07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Long-term depress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6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ell cycl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7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xon guidanc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4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ABAergic synaps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6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athways in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0E-07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BC transporter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1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ndocytosi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6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utamatergic synaps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2E-06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Oxytocin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6E-07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FoxO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2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Fc gamma R-mediated phagocytosis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1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Pathways in cancer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4.4E-06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nRH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8.4E-07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HTLV-I infec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0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CM-receptor interac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Dilated cardiomyopath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1E-05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Wnt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1E-06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entral carbon metabolism in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1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I3K-Akt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2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Gap junction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1E-05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hyroid hormone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1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ap junc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1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as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5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GnRH signaling 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1E-05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as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Biosynthesis - </a:t>
                      </a:r>
                      <a:r>
                        <a:rPr lang="en-US" sz="600" u="none" strike="noStrike" baseline="0" dirty="0" err="1">
                          <a:effectLst/>
                        </a:rPr>
                        <a:t>heparan</a:t>
                      </a:r>
                      <a:r>
                        <a:rPr lang="en-US" sz="600" u="none" strike="noStrike" baseline="0" dirty="0">
                          <a:effectLst/>
                        </a:rPr>
                        <a:t> sulfate / heparin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Actin cytoskeleton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2.7E-02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Vascular smooth muscle contrac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3E-05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Dopaminergic synapse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Inositol phosphate metabolism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enal cell carcinoma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8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astric acid secre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1E-05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AMP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ancreatic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y, Ser, Thr metabolism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0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Neuroactive ligand-receptor interaction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0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Insulin resistance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7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hyroid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3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utamatergic synaps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0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ircadian entrainment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tein processing in endoplasmic reticulum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3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VEGF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3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GF-beta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3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drenergic signaling in cardiomyocyte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strogen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9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ardiac muscle contrac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 err="1">
                          <a:effectLst/>
                        </a:rPr>
                        <a:t>Adherens</a:t>
                      </a:r>
                      <a:r>
                        <a:rPr lang="en-US" sz="600" u="none" strike="noStrike" baseline="0" dirty="0">
                          <a:effectLst/>
                        </a:rPr>
                        <a:t> junction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9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holinergic synaps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9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holinergic synapse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1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astric acid secre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Arginine biosynthesis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4.9E-02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ap1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1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elanogenesi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6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dipocytokine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Serotonergic synaps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3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ype II diabetes mellitu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8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myotrophic lateral sclerosis (ALS)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7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ldosterone synthesis and secre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1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rbB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2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RNA surveillance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8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elanogenesi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5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hosphatidylinositol signaling system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5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ircadian rhythm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0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Salivary secre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1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APK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8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NF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1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xon guidance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9E-04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olorectal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0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 cell receptor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3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 err="1">
                          <a:effectLst/>
                        </a:rPr>
                        <a:t>Arrhythmogenic</a:t>
                      </a:r>
                      <a:r>
                        <a:rPr lang="en-US" sz="600" u="none" strike="noStrike" baseline="0" dirty="0">
                          <a:effectLst/>
                        </a:rPr>
                        <a:t> right ventricular cardiomyopath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Sphingolipid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0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Oocyte meiosi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3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dherens junc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Insulin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5E-05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Starch and sucrose metabolism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4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strogen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7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Long-term potentia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TOR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5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hyroid cancer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7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teoglycans in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etabolic pathway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8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Insulin secre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8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Amphetamine addiction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ocaine addic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9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Inflammatory mediator regulation of TRP channel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1.8E-03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dherens junc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Notch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9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egulation of actin cytoskelet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9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lactin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0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Dilated cardiomyopath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0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Bladder cancer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3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ircadian entrainment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1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latelet activa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0E-02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latelet activa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6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Insulin secre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7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enal cell carcinoma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3.4E-02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APK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8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CM-receptor interac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4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3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Long-term potentia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0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GMP-PKG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2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alcium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6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Basal cell carcinoma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7.4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hemokine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3.8E-03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Neurotrophin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8.0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as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1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ndocytosi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8.9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hyroid hormone synthesi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4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ldosterone synthesis and secre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4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GMP-PKG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1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Hippo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7E-04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1"/>
                      <a:endParaRPr lang="en-US" sz="600" b="1" i="0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Thyroid hormone signaling pathway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5.4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oxoplasmosi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0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Focal adhes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6.6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ndometrial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1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AMP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8.9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etrograde endocannabinoid signaling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ioma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3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state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3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Hypertrophic cardiomyopathy (HCM)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9.8E-03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utamatergic synapse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4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teoglycans in cancer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MPK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Oocyte meiosi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Small cell lung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Wnt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2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alcium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0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7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Non-small cell lung cancer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3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ioma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1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Melanoma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5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 err="1">
                          <a:effectLst/>
                        </a:rPr>
                        <a:t>Arrhythmogenic</a:t>
                      </a:r>
                      <a:r>
                        <a:rPr lang="en-US" sz="600" u="none" strike="noStrike" baseline="0" dirty="0">
                          <a:effectLst/>
                        </a:rPr>
                        <a:t> ventricular cardiomyopathy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5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ancreatic secre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gesterone-mediated oocyte maturati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6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ndocytosi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6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ap1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1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rogesterone-mediated oocyte matura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8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Regulation of actin cytoskeleton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1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ErbB signaling pathway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1.8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Glycerophospholipid metabolism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3.3E-03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3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Transcriptional misregulation in cancer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0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Glucagon signaling pathway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6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Long-term depress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1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PI3K-Akt signaling pathway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7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entral carbon metabolism in cancer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2.6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Fc gamma R-mediated phagocytosi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8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6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mphetamine addic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3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moebiasis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8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Nicotine addiction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3.5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Hepatitis B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0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Amoebiasis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2E-02</a:t>
                      </a:r>
                      <a:endParaRPr lang="en-US" sz="600" b="1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>
                          <a:effectLst/>
                        </a:rPr>
                        <a:t>Choline metabolism in cancer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>
                          <a:effectLst/>
                        </a:rPr>
                        <a:t>4.1E-03</a:t>
                      </a:r>
                      <a:endParaRPr lang="en-US" sz="6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Dopaminergic synapse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4.3E-02</a:t>
                      </a:r>
                      <a:endParaRPr lang="en-US" sz="600" b="1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baseline="0" dirty="0">
                          <a:effectLst/>
                        </a:rPr>
                        <a:t>Ubiquitin mediated proteolysis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baseline="0" dirty="0">
                          <a:effectLst/>
                        </a:rPr>
                        <a:t>4.9E-03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60"/>
                  </a:ext>
                </a:extLst>
              </a:tr>
            </a:tbl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6965AA4B-B240-40D1-B570-7A5D8EB7BD95}"/>
              </a:ext>
            </a:extLst>
          </p:cNvPr>
          <p:cNvSpPr txBox="1"/>
          <p:nvPr/>
        </p:nvSpPr>
        <p:spPr>
          <a:xfrm>
            <a:off x="1340740" y="30915"/>
            <a:ext cx="7099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Table </a:t>
            </a:r>
            <a:r>
              <a:rPr lang="en-US" sz="1400" b="1" smtClean="0"/>
              <a:t>S3. </a:t>
            </a:r>
            <a:r>
              <a:rPr lang="en-US" sz="1400" b="1" dirty="0"/>
              <a:t>Enriched pathways of regulated genes in AMY and ACC </a:t>
            </a:r>
            <a:r>
              <a:rPr lang="en-US" sz="1400" b="1" dirty="0">
                <a:solidFill>
                  <a:prstClr val="black"/>
                </a:solidFill>
              </a:rPr>
              <a:t>at 2 and 5 weeks post stress</a:t>
            </a:r>
            <a:r>
              <a:rPr lang="en-US" sz="1400" b="1" dirty="0"/>
              <a:t>.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1371527" y="756996"/>
            <a:ext cx="1924594" cy="870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350392" y="761346"/>
            <a:ext cx="19792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5540803" y="756986"/>
            <a:ext cx="35857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9205721" y="756986"/>
            <a:ext cx="141723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5553864" y="595868"/>
            <a:ext cx="506908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348001" y="591511"/>
            <a:ext cx="39903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371527" y="374984"/>
            <a:ext cx="9247471" cy="1037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523927" y="6778076"/>
            <a:ext cx="9247471" cy="1037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3474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61</Words>
  <Application>Microsoft Office PowerPoint</Application>
  <PresentationFormat>Widescreen</PresentationFormat>
  <Paragraphs>3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IEI TANAKA</dc:creator>
  <cp:lastModifiedBy>YUMIN ZHANG</cp:lastModifiedBy>
  <cp:revision>19</cp:revision>
  <dcterms:created xsi:type="dcterms:W3CDTF">2019-03-07T14:38:56Z</dcterms:created>
  <dcterms:modified xsi:type="dcterms:W3CDTF">2019-03-07T22:26:27Z</dcterms:modified>
</cp:coreProperties>
</file>